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7772400" cy="10058400"/>
  <p:notesSz cx="6858000" cy="9144000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742"/>
    <p:restoredTop sz="94554"/>
  </p:normalViewPr>
  <p:slideViewPr>
    <p:cSldViewPr snapToGrid="0" snapToObjects="1">
      <p:cViewPr varScale="1">
        <p:scale>
          <a:sx n="70" d="100"/>
          <a:sy n="70" d="100"/>
        </p:scale>
        <p:origin x="212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741B94A1-23ED-DE7A-B309-11D2F5E2710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98C2A17-71D2-21CE-7482-FAE954DEDB46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9AB93587-5DBA-4442-B4B9-27AC86A99425}" type="datetimeFigureOut">
              <a:rPr lang="en-US"/>
              <a:pPr>
                <a:defRPr/>
              </a:pPr>
              <a:t>1/13/24</a:t>
            </a:fld>
            <a:endParaRPr lang="en-US"/>
          </a:p>
        </p:txBody>
      </p:sp>
      <p:sp>
        <p:nvSpPr>
          <p:cNvPr id="4" name="Slide Image Placeholder 3">
            <a:extLst>
              <a:ext uri="{FF2B5EF4-FFF2-40B4-BE49-F238E27FC236}">
                <a16:creationId xmlns:a16="http://schemas.microsoft.com/office/drawing/2014/main" id="{B06E29E3-966B-F22A-0FAC-26326A025300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>
            <a:extLst>
              <a:ext uri="{FF2B5EF4-FFF2-40B4-BE49-F238E27FC236}">
                <a16:creationId xmlns:a16="http://schemas.microsoft.com/office/drawing/2014/main" id="{E9998167-011B-7A0F-C7A4-F8A70CDF0CF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4F0D98-FDCF-C955-FC2B-4FA0A5824F04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0EEF4D-9889-E0C1-BAC1-F4BA2E5564AB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8FC5C014-0097-2D4E-A4D7-51EA33D3AB5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7" name="Slide Image Placeholder 1">
            <a:extLst>
              <a:ext uri="{FF2B5EF4-FFF2-40B4-BE49-F238E27FC236}">
                <a16:creationId xmlns:a16="http://schemas.microsoft.com/office/drawing/2014/main" id="{72575528-21B8-E32A-DE53-FB58EDC8DBF9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098" name="Notes Placeholder 2">
            <a:extLst>
              <a:ext uri="{FF2B5EF4-FFF2-40B4-BE49-F238E27FC236}">
                <a16:creationId xmlns:a16="http://schemas.microsoft.com/office/drawing/2014/main" id="{4DA9193F-E01F-C1E6-9DBB-F9DB46AC1F8A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>
              <a:spcBef>
                <a:spcPct val="0"/>
              </a:spcBef>
            </a:pPr>
            <a:endParaRPr lang="en-US" altLang="en-US"/>
          </a:p>
        </p:txBody>
      </p:sp>
      <p:sp>
        <p:nvSpPr>
          <p:cNvPr id="4099" name="Slide Number Placeholder 3">
            <a:extLst>
              <a:ext uri="{FF2B5EF4-FFF2-40B4-BE49-F238E27FC236}">
                <a16:creationId xmlns:a16="http://schemas.microsoft.com/office/drawing/2014/main" id="{C9A68427-C559-A928-446F-ABB6552AA13D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AFA65302-A766-BA43-A437-1E7559EE112A}" type="slidenum">
              <a:rPr lang="en-US" altLang="en-US"/>
              <a:pPr fontAlgn="base">
                <a:spcBef>
                  <a:spcPct val="0"/>
                </a:spcBef>
                <a:spcAft>
                  <a:spcPct val="0"/>
                </a:spcAft>
              </a:pPr>
              <a:t>1</a:t>
            </a:fld>
            <a:endParaRPr lang="en-US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79D171-9600-DECA-D340-CA062D38E8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CF4E50-972C-4544-BE4C-50B5DA805548}" type="datetimeFigureOut">
              <a:rPr lang="en-US"/>
              <a:pPr>
                <a:defRPr/>
              </a:pPr>
              <a:t>1/1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2B04C0-04FF-7DAD-97E7-7C87A62BF6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77CCE4-FCBA-FDAA-24C8-43AFE678A9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1C9454-7A44-0C44-ADE8-E2E67EA135A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83577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13C9E0-05E0-DF2B-8AFF-5CACD386A2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810A91-65FB-6F49-A719-1C954C558228}" type="datetimeFigureOut">
              <a:rPr lang="en-US"/>
              <a:pPr>
                <a:defRPr/>
              </a:pPr>
              <a:t>1/1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1D2F80-C756-8037-79E6-4D549CFB3F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12364B-A5EE-20E6-66B6-66E5620E5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6F704E-08C1-094B-AA39-32CC644EB74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7610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9FEC71-B391-98E5-4C18-18416BB28B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3474CD-AD0F-A540-B11C-3A713D12200F}" type="datetimeFigureOut">
              <a:rPr lang="en-US"/>
              <a:pPr>
                <a:defRPr/>
              </a:pPr>
              <a:t>1/1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4F9B9C-4527-44B3-E467-CDFF20092E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5EF792-72CA-4846-0365-72CCFEF76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639B88-E9D4-6343-8ACC-0FAF8C9F898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9607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7A8D79-623D-434D-0444-AFFBD73399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3874DE-AD5A-5D41-AE8D-60D73486413A}" type="datetimeFigureOut">
              <a:rPr lang="en-US"/>
              <a:pPr>
                <a:defRPr/>
              </a:pPr>
              <a:t>1/1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BA4012-5D13-4B71-6AAC-BB2B987426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61C898-DDDB-909E-5CB5-75CE77A94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80DC6B-C3D6-7949-806B-EFF26B54890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392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65A923-0C0C-60A4-8AD6-1DF477B59C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52F1A2-FBC8-3A46-BE37-278330F59735}" type="datetimeFigureOut">
              <a:rPr lang="en-US"/>
              <a:pPr>
                <a:defRPr/>
              </a:pPr>
              <a:t>1/1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48583E-D955-4606-EC7F-73E83753D4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C35E0E-3790-7EC1-10E8-787092CEFF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043E59-6DE9-F443-8D7D-61F8E4BFBB9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0124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FC4A5A5D-F138-6452-7475-B87E61533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189563-FC4E-404F-A104-AFA095FB5E74}" type="datetimeFigureOut">
              <a:rPr lang="en-US"/>
              <a:pPr>
                <a:defRPr/>
              </a:pPr>
              <a:t>1/13/24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251781FA-CDF9-D32C-5D51-A5929C4780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E1B8DE3A-7DAA-3FE1-B736-DFA8740708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30A254-B7E1-3342-9874-FBADCA54E18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05028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3C0B70B1-F407-7B35-DA48-9F2897ED83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85F9CB-3E9C-E84E-A255-A5D32C4EE767}" type="datetimeFigureOut">
              <a:rPr lang="en-US"/>
              <a:pPr>
                <a:defRPr/>
              </a:pPr>
              <a:t>1/13/24</a:t>
            </a:fld>
            <a:endParaRPr 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D4295462-67CD-9B56-D2AF-4926ECCD4C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140D1B69-9846-D406-F375-3E79A22634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8904C4-975C-2C4C-BD13-7B6AEF3A8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3205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1656E3E0-B2EB-3552-31D5-2C264907EB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DECA87-0952-3B40-92FD-C992FC7C14C9}" type="datetimeFigureOut">
              <a:rPr lang="en-US"/>
              <a:pPr>
                <a:defRPr/>
              </a:pPr>
              <a:t>1/13/24</a:t>
            </a:fld>
            <a:endParaRPr 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65FE5131-3590-7982-E014-9A72CF930A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9FA458DD-BF6B-3570-9EAE-828A1066CC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044B16-064E-244D-B749-B23464E0DE7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378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276D5F28-9A48-AF60-71B4-6116E5D46B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DC62F9-6AE2-0548-AE06-C41569B20CC3}" type="datetimeFigureOut">
              <a:rPr lang="en-US"/>
              <a:pPr>
                <a:defRPr/>
              </a:pPr>
              <a:t>1/13/24</a:t>
            </a:fld>
            <a:endParaRPr 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38CA615A-8D10-7B4B-4793-55A62882DF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F153E3A1-525F-2942-35C3-766286D027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439034-7F46-A343-8514-3809D6ADEC4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59215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63E851E5-3EC8-A88E-F8E2-377BAB724E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DBD4DD-FBA7-3147-8A40-11567792CB76}" type="datetimeFigureOut">
              <a:rPr lang="en-US"/>
              <a:pPr>
                <a:defRPr/>
              </a:pPr>
              <a:t>1/13/24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7314D643-CC0E-1ADD-0098-02859F66A9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812AEAA0-A387-57E1-97F3-1D1576956F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0C989E-2BF3-E040-80CD-3908A36896F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151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BAC06FE0-1398-B2E1-C491-40134A3C14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19B08B-2418-0E45-9618-856BA368FA7B}" type="datetimeFigureOut">
              <a:rPr lang="en-US"/>
              <a:pPr>
                <a:defRPr/>
              </a:pPr>
              <a:t>1/13/24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29F531D7-D229-BFC6-B5B1-AA1562DF57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B8B4440F-6541-8925-B483-F031E2637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1DB226-C71D-4149-B8AB-53E200D7EE9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318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C5F583E-E82A-17CC-92C6-1F508F6C96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34988" y="534988"/>
            <a:ext cx="6702425" cy="194468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1E8EFE-AB62-01C8-A5C8-8CC1E29EE7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34988" y="2678113"/>
            <a:ext cx="6702425" cy="63817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C3CC7F-2C20-BEC6-C1B6-59CBD61E339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534988" y="9323388"/>
            <a:ext cx="1747837" cy="53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02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0B81EB79-EFFD-294F-B2A2-9B97A8D9A80C}" type="datetimeFigureOut">
              <a:rPr lang="en-US"/>
              <a:pPr>
                <a:defRPr/>
              </a:pPr>
              <a:t>1/1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A88C97-1CEB-5B06-9AAF-477D636BD8D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574925" y="9323388"/>
            <a:ext cx="2622550" cy="53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02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EE392F-005F-EF82-8455-373AD615F9B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5489575" y="9323388"/>
            <a:ext cx="1747838" cy="53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02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DE8FA8DA-4C9B-3F4B-8644-20A82AC887E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2pPr>
      <a:lvl3pPr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3pPr>
      <a:lvl4pPr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4pPr>
      <a:lvl5pPr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5pPr>
      <a:lvl6pPr marL="457200"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6pPr>
      <a:lvl7pPr marL="914400"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7pPr>
      <a:lvl8pPr marL="1371600"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8pPr>
      <a:lvl9pPr marL="1828800"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193675" indent="-193675" algn="l" defTabSz="776288" rtl="0" fontAlgn="base">
        <a:lnSpc>
          <a:spcPct val="90000"/>
        </a:lnSpc>
        <a:spcBef>
          <a:spcPts val="850"/>
        </a:spcBef>
        <a:spcAft>
          <a:spcPct val="0"/>
        </a:spcAft>
        <a:buFont typeface="Arial" panose="020B0604020202020204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1pPr>
      <a:lvl2pPr marL="582613" indent="-193675" algn="l" defTabSz="776288" rtl="0" fontAlgn="base">
        <a:lnSpc>
          <a:spcPct val="90000"/>
        </a:lnSpc>
        <a:spcBef>
          <a:spcPts val="425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3675" algn="l" defTabSz="776288" rtl="0" fontAlgn="base">
        <a:lnSpc>
          <a:spcPct val="90000"/>
        </a:lnSpc>
        <a:spcBef>
          <a:spcPts val="425"/>
        </a:spcBef>
        <a:spcAft>
          <a:spcPct val="0"/>
        </a:spcAft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58900" indent="-193675" algn="l" defTabSz="776288" rtl="0" fontAlgn="base">
        <a:lnSpc>
          <a:spcPct val="90000"/>
        </a:lnSpc>
        <a:spcBef>
          <a:spcPts val="42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747838" indent="-193675" algn="l" defTabSz="776288" rtl="0" fontAlgn="base">
        <a:lnSpc>
          <a:spcPct val="90000"/>
        </a:lnSpc>
        <a:spcBef>
          <a:spcPts val="42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5" name="TextBox 43">
            <a:extLst>
              <a:ext uri="{FF2B5EF4-FFF2-40B4-BE49-F238E27FC236}">
                <a16:creationId xmlns:a16="http://schemas.microsoft.com/office/drawing/2014/main" id="{4487A542-E3B9-9493-E670-383D35A6B5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900" y="876237"/>
            <a:ext cx="3143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3077" name="Picture 5">
            <a:extLst>
              <a:ext uri="{FF2B5EF4-FFF2-40B4-BE49-F238E27FC236}">
                <a16:creationId xmlns:a16="http://schemas.microsoft.com/office/drawing/2014/main" id="{5A07B8EC-9855-8E13-5C4F-9FFA10F1497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/>
          <a:srcRect/>
          <a:stretch/>
        </p:blipFill>
        <p:spPr bwMode="auto">
          <a:xfrm>
            <a:off x="469900" y="1065172"/>
            <a:ext cx="1719263" cy="26463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79" name="TextBox 14">
            <a:extLst>
              <a:ext uri="{FF2B5EF4-FFF2-40B4-BE49-F238E27FC236}">
                <a16:creationId xmlns:a16="http://schemas.microsoft.com/office/drawing/2014/main" id="{F9BFAA8D-E205-EBE0-479C-8A8C4D6185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54250" y="892112"/>
            <a:ext cx="3145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1857550-E743-016D-DDE0-11487024D00E}"/>
              </a:ext>
            </a:extLst>
          </p:cNvPr>
          <p:cNvSpPr txBox="1"/>
          <p:nvPr/>
        </p:nvSpPr>
        <p:spPr>
          <a:xfrm>
            <a:off x="1724099" y="1594104"/>
            <a:ext cx="8305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SzPct val="130000"/>
              <a:buFont typeface="Arial" panose="020B0604020202020204" pitchFamily="34" charset="0"/>
              <a:buChar char="•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  <a:p>
            <a:pPr marL="171450" indent="-171450">
              <a:buSzPct val="80000"/>
              <a:buFont typeface="Courier New" panose="02070309020205020404" pitchFamily="49" charset="0"/>
              <a:buChar char="o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50EB51C-1009-9EDE-E2D7-3594B739FDB3}"/>
              </a:ext>
            </a:extLst>
          </p:cNvPr>
          <p:cNvSpPr txBox="1"/>
          <p:nvPr/>
        </p:nvSpPr>
        <p:spPr>
          <a:xfrm>
            <a:off x="3739866" y="1594104"/>
            <a:ext cx="8305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SzPct val="130000"/>
              <a:buFont typeface="Arial" panose="020B0604020202020204" pitchFamily="34" charset="0"/>
              <a:buChar char="•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  <a:p>
            <a:pPr marL="171450" indent="-171450">
              <a:buSzPct val="80000"/>
              <a:buFont typeface="Courier New" panose="02070309020205020404" pitchFamily="49" charset="0"/>
              <a:buChar char="o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</a:p>
        </p:txBody>
      </p:sp>
      <p:pic>
        <p:nvPicPr>
          <p:cNvPr id="4" name="Picture 5">
            <a:extLst>
              <a:ext uri="{FF2B5EF4-FFF2-40B4-BE49-F238E27FC236}">
                <a16:creationId xmlns:a16="http://schemas.microsoft.com/office/drawing/2014/main" id="{77A4AAAD-EBA5-123F-0CFA-FBB80C5E8B4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/>
          <a:srcRect/>
          <a:stretch/>
        </p:blipFill>
        <p:spPr bwMode="auto">
          <a:xfrm>
            <a:off x="2505716" y="1065172"/>
            <a:ext cx="1719262" cy="26463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E6FA4258-A43A-22C0-7752-01A0CB5B8E21}"/>
              </a:ext>
            </a:extLst>
          </p:cNvPr>
          <p:cNvSpPr/>
          <p:nvPr/>
        </p:nvSpPr>
        <p:spPr>
          <a:xfrm>
            <a:off x="5018400" y="4294946"/>
            <a:ext cx="1114453" cy="79734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30E71EB-F7A3-8A37-306A-203A2AFAF9EC}"/>
              </a:ext>
            </a:extLst>
          </p:cNvPr>
          <p:cNvSpPr txBox="1"/>
          <p:nvPr/>
        </p:nvSpPr>
        <p:spPr>
          <a:xfrm>
            <a:off x="466314" y="3867959"/>
            <a:ext cx="6547104" cy="42516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Fig. S1: P15 and P20 WT mice exhibit contextual fear memory formation capabilities, and P21 mice exhibit no baseline freezing differences.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A</a:t>
            </a:r>
            <a:r>
              <a:rPr lang="en-US" sz="12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Quantification of the percentage time freezing on testing day of No Shock (n = 10) and Shock (n = 11) mice trained on P15 and tested 1 d later. The Shock group exhibited significantly more freezing than the No Shock group (**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&lt; .01). 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Quantification of the percentage time freezing on testing day of No Shock (n = 7) and Shock (n = 8) mice trained on P20 and tested 1 d later. The Shock group exhibited significantly more freezing than No Shock (**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&lt; .01).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Quantification of the percentage time freezing during the initial 2-min exposure to the chamber on training day and prior to any shocks administered (baseline freezing) on P21 (No Shock group: n = 12; Shock group: n = 13). There were no significant differences found in freezing responses between the </a:t>
            </a:r>
            <a:r>
              <a:rPr lang="en-US" sz="120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wo groups </a:t>
            </a:r>
            <a:r>
              <a:rPr lang="en-US" sz="1200" i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p </a:t>
            </a:r>
            <a:r>
              <a:rPr lang="en-US" sz="120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 .3571)</a:t>
            </a:r>
            <a:r>
              <a:rPr lang="en-US" sz="1200" i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US" sz="1200" i="1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D4815BA-3A1F-BE63-1CAD-62479823ACBC}"/>
              </a:ext>
            </a:extLst>
          </p:cNvPr>
          <p:cNvSpPr txBox="1"/>
          <p:nvPr/>
        </p:nvSpPr>
        <p:spPr>
          <a:xfrm>
            <a:off x="210407" y="442767"/>
            <a:ext cx="3523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S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309409B-4971-36D3-C5CE-001E64DB262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5069"/>
          <a:stretch/>
        </p:blipFill>
        <p:spPr>
          <a:xfrm>
            <a:off x="4575372" y="1792136"/>
            <a:ext cx="1448646" cy="191935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76FB01CF-7B27-5690-873A-50B13F328AB6}"/>
              </a:ext>
            </a:extLst>
          </p:cNvPr>
          <p:cNvSpPr txBox="1"/>
          <p:nvPr/>
        </p:nvSpPr>
        <p:spPr>
          <a:xfrm>
            <a:off x="5755633" y="1652016"/>
            <a:ext cx="8305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SzPct val="130000"/>
              <a:buFont typeface="Arial" panose="020B0604020202020204" pitchFamily="34" charset="0"/>
              <a:buChar char="•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  <a:p>
            <a:pPr marL="171450" indent="-171450">
              <a:buSzPct val="80000"/>
              <a:buFont typeface="Courier New" panose="02070309020205020404" pitchFamily="49" charset="0"/>
              <a:buChar char="o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BCE65394-3557-3536-188B-9BFB325E4C7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83156"/>
          <a:stretch/>
        </p:blipFill>
        <p:spPr>
          <a:xfrm>
            <a:off x="4551068" y="1070949"/>
            <a:ext cx="1448646" cy="380651"/>
          </a:xfrm>
          <a:prstGeom prst="rect">
            <a:avLst/>
          </a:prstGeom>
        </p:spPr>
      </p:pic>
      <p:sp>
        <p:nvSpPr>
          <p:cNvPr id="12" name="TextBox 14">
            <a:extLst>
              <a:ext uri="{FF2B5EF4-FFF2-40B4-BE49-F238E27FC236}">
                <a16:creationId xmlns:a16="http://schemas.microsoft.com/office/drawing/2014/main" id="{9711A8A8-1199-88C7-B891-58AB74D4AE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76444" y="878292"/>
            <a:ext cx="3145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52</TotalTime>
  <Words>206</Words>
  <Application>Microsoft Macintosh PowerPoint</Application>
  <PresentationFormat>Custom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urier New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andra Lanjewar</dc:creator>
  <cp:lastModifiedBy>Alexandra Lanjewar</cp:lastModifiedBy>
  <cp:revision>21</cp:revision>
  <dcterms:created xsi:type="dcterms:W3CDTF">2021-09-14T19:43:25Z</dcterms:created>
  <dcterms:modified xsi:type="dcterms:W3CDTF">2024-01-13T20:22:35Z</dcterms:modified>
</cp:coreProperties>
</file>